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  <p:sldMasterId id="2147483685" r:id="rId2"/>
  </p:sldMasterIdLst>
  <p:notesMasterIdLst>
    <p:notesMasterId r:id="rId4"/>
  </p:notesMasterIdLst>
  <p:sldIdLst>
    <p:sldId id="725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精山明敏" initials="精山明敏" lastIdx="1" clrIdx="0">
    <p:extLst>
      <p:ext uri="{19B8F6BF-5375-455C-9EA6-DF929625EA0E}">
        <p15:presenceInfo xmlns:p15="http://schemas.microsoft.com/office/powerpoint/2012/main" userId="精山明敏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 autoAdjust="0"/>
    <p:restoredTop sz="94599" autoAdjust="0"/>
  </p:normalViewPr>
  <p:slideViewPr>
    <p:cSldViewPr snapToGrid="0">
      <p:cViewPr varScale="1">
        <p:scale>
          <a:sx n="81" d="100"/>
          <a:sy n="81" d="100"/>
        </p:scale>
        <p:origin x="301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他方向と視野角!$B$1:$B$2</c:f>
              <c:strCache>
                <c:ptCount val="2"/>
                <c:pt idx="0">
                  <c:v>他方向</c:v>
                </c:pt>
                <c:pt idx="1">
                  <c:v>移動割合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他方向と視野角!$A$3:$A$29</c:f>
              <c:numCache>
                <c:formatCode>0.0_);[Red]\(0.0\)</c:formatCode>
                <c:ptCount val="27"/>
                <c:pt idx="0">
                  <c:v>3</c:v>
                </c:pt>
                <c:pt idx="1">
                  <c:v>3</c:v>
                </c:pt>
                <c:pt idx="2">
                  <c:v>2.5</c:v>
                </c:pt>
                <c:pt idx="3">
                  <c:v>4</c:v>
                </c:pt>
                <c:pt idx="4">
                  <c:v>4</c:v>
                </c:pt>
                <c:pt idx="5">
                  <c:v>4.5</c:v>
                </c:pt>
                <c:pt idx="6">
                  <c:v>3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8</c:v>
                </c:pt>
                <c:pt idx="18">
                  <c:v>10</c:v>
                </c:pt>
                <c:pt idx="19">
                  <c:v>10</c:v>
                </c:pt>
                <c:pt idx="20">
                  <c:v>12</c:v>
                </c:pt>
                <c:pt idx="21">
                  <c:v>14</c:v>
                </c:pt>
                <c:pt idx="22">
                  <c:v>15</c:v>
                </c:pt>
                <c:pt idx="23">
                  <c:v>15</c:v>
                </c:pt>
                <c:pt idx="24">
                  <c:v>15</c:v>
                </c:pt>
                <c:pt idx="25">
                  <c:v>20</c:v>
                </c:pt>
                <c:pt idx="26">
                  <c:v>20</c:v>
                </c:pt>
              </c:numCache>
            </c:numRef>
          </c:xVal>
          <c:yVal>
            <c:numRef>
              <c:f>他方向と視野角!$B$3:$B$29</c:f>
              <c:numCache>
                <c:formatCode>General</c:formatCode>
                <c:ptCount val="27"/>
                <c:pt idx="0">
                  <c:v>15.4</c:v>
                </c:pt>
                <c:pt idx="1">
                  <c:v>91.6</c:v>
                </c:pt>
                <c:pt idx="2">
                  <c:v>8.3000000000000007</c:v>
                </c:pt>
                <c:pt idx="3">
                  <c:v>76.900000000000006</c:v>
                </c:pt>
                <c:pt idx="4">
                  <c:v>12.4</c:v>
                </c:pt>
                <c:pt idx="5">
                  <c:v>18.7</c:v>
                </c:pt>
                <c:pt idx="6">
                  <c:v>11.7</c:v>
                </c:pt>
                <c:pt idx="7">
                  <c:v>14.3</c:v>
                </c:pt>
                <c:pt idx="8">
                  <c:v>16.600000000000001</c:v>
                </c:pt>
                <c:pt idx="9">
                  <c:v>18.2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37.5</c:v>
                </c:pt>
                <c:pt idx="15">
                  <c:v>50</c:v>
                </c:pt>
                <c:pt idx="16">
                  <c:v>0</c:v>
                </c:pt>
                <c:pt idx="17">
                  <c:v>42.9</c:v>
                </c:pt>
                <c:pt idx="18">
                  <c:v>33.1</c:v>
                </c:pt>
                <c:pt idx="19">
                  <c:v>42.8</c:v>
                </c:pt>
                <c:pt idx="20">
                  <c:v>10</c:v>
                </c:pt>
                <c:pt idx="21">
                  <c:v>0</c:v>
                </c:pt>
                <c:pt idx="22">
                  <c:v>0</c:v>
                </c:pt>
                <c:pt idx="23">
                  <c:v>15.8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9D1-449A-A9CE-CFD9CACADD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8314296"/>
        <c:axId val="237436792"/>
      </c:scatterChart>
      <c:valAx>
        <c:axId val="238314296"/>
        <c:scaling>
          <c:orientation val="minMax"/>
          <c:max val="20"/>
        </c:scaling>
        <c:delete val="0"/>
        <c:axPos val="b"/>
        <c:numFmt formatCode="#,##0_);[Red]\(#,##0\)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7436792"/>
        <c:crosses val="autoZero"/>
        <c:crossBetween val="midCat"/>
        <c:majorUnit val="5"/>
      </c:valAx>
      <c:valAx>
        <c:axId val="237436792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8314296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7!$C$1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8.6583770778652674E-2"/>
                  <c:y val="-0.5427034120734908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baseline="0" dirty="0"/>
                      <a:t>y = -0.3521x + 14.766</a:t>
                    </a:r>
                    <a:br>
                      <a:rPr lang="en-US" baseline="0" dirty="0"/>
                    </a:br>
                    <a:r>
                      <a:rPr lang="en-US" baseline="0" dirty="0"/>
                      <a:t>r = -0.459</a:t>
                    </a:r>
                    <a:endParaRPr lang="en-US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7!$B$2:$B$32</c:f>
              <c:numCache>
                <c:formatCode>0.0_);[Red]\(0.0\)</c:formatCode>
                <c:ptCount val="31"/>
                <c:pt idx="1">
                  <c:v>3</c:v>
                </c:pt>
                <c:pt idx="2">
                  <c:v>3</c:v>
                </c:pt>
                <c:pt idx="3">
                  <c:v>2.5</c:v>
                </c:pt>
                <c:pt idx="4">
                  <c:v>4</c:v>
                </c:pt>
                <c:pt idx="5">
                  <c:v>4</c:v>
                </c:pt>
                <c:pt idx="6">
                  <c:v>4.5</c:v>
                </c:pt>
                <c:pt idx="7">
                  <c:v>3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7</c:v>
                </c:pt>
                <c:pt idx="18">
                  <c:v>8</c:v>
                </c:pt>
                <c:pt idx="19">
                  <c:v>10</c:v>
                </c:pt>
                <c:pt idx="20">
                  <c:v>10</c:v>
                </c:pt>
                <c:pt idx="21">
                  <c:v>12</c:v>
                </c:pt>
                <c:pt idx="22">
                  <c:v>14</c:v>
                </c:pt>
                <c:pt idx="23">
                  <c:v>15</c:v>
                </c:pt>
                <c:pt idx="24">
                  <c:v>15</c:v>
                </c:pt>
                <c:pt idx="25">
                  <c:v>15</c:v>
                </c:pt>
                <c:pt idx="26">
                  <c:v>20</c:v>
                </c:pt>
                <c:pt idx="27">
                  <c:v>20</c:v>
                </c:pt>
              </c:numCache>
            </c:numRef>
          </c:xVal>
          <c:yVal>
            <c:numRef>
              <c:f>Sheet7!$C$2:$C$32</c:f>
              <c:numCache>
                <c:formatCode>General</c:formatCode>
                <c:ptCount val="31"/>
                <c:pt idx="1">
                  <c:v>9</c:v>
                </c:pt>
                <c:pt idx="2">
                  <c:v>20</c:v>
                </c:pt>
                <c:pt idx="3">
                  <c:v>11</c:v>
                </c:pt>
                <c:pt idx="4">
                  <c:v>24</c:v>
                </c:pt>
                <c:pt idx="5">
                  <c:v>14</c:v>
                </c:pt>
                <c:pt idx="6">
                  <c:v>13</c:v>
                </c:pt>
                <c:pt idx="7">
                  <c:v>20</c:v>
                </c:pt>
                <c:pt idx="8">
                  <c:v>11</c:v>
                </c:pt>
                <c:pt idx="9">
                  <c:v>16</c:v>
                </c:pt>
                <c:pt idx="10">
                  <c:v>9</c:v>
                </c:pt>
                <c:pt idx="11">
                  <c:v>10</c:v>
                </c:pt>
                <c:pt idx="12">
                  <c:v>13</c:v>
                </c:pt>
                <c:pt idx="13">
                  <c:v>8</c:v>
                </c:pt>
                <c:pt idx="14">
                  <c:v>11</c:v>
                </c:pt>
                <c:pt idx="15">
                  <c:v>11</c:v>
                </c:pt>
                <c:pt idx="16">
                  <c:v>10</c:v>
                </c:pt>
                <c:pt idx="17">
                  <c:v>14</c:v>
                </c:pt>
                <c:pt idx="18">
                  <c:v>9</c:v>
                </c:pt>
                <c:pt idx="19">
                  <c:v>9</c:v>
                </c:pt>
                <c:pt idx="20">
                  <c:v>10</c:v>
                </c:pt>
                <c:pt idx="21">
                  <c:v>8</c:v>
                </c:pt>
                <c:pt idx="22">
                  <c:v>10</c:v>
                </c:pt>
                <c:pt idx="23">
                  <c:v>10</c:v>
                </c:pt>
                <c:pt idx="24">
                  <c:v>11</c:v>
                </c:pt>
                <c:pt idx="25">
                  <c:v>10</c:v>
                </c:pt>
                <c:pt idx="26">
                  <c:v>9</c:v>
                </c:pt>
                <c:pt idx="27">
                  <c:v>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9DA-435A-9900-55E8D23DE1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45224"/>
        <c:axId val="207022896"/>
      </c:scatterChart>
      <c:valAx>
        <c:axId val="15245224"/>
        <c:scaling>
          <c:orientation val="minMax"/>
          <c:max val="20"/>
        </c:scaling>
        <c:delete val="1"/>
        <c:axPos val="b"/>
        <c:numFmt formatCode="0.0_);[Red]\(0.0\)" sourceLinked="1"/>
        <c:majorTickMark val="out"/>
        <c:minorTickMark val="none"/>
        <c:tickLblPos val="nextTo"/>
        <c:crossAx val="207022896"/>
        <c:crosses val="autoZero"/>
        <c:crossBetween val="midCat"/>
      </c:valAx>
      <c:valAx>
        <c:axId val="207022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2452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8!$C$1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3.7412095639943743E-2"/>
                  <c:y val="-0.5002352430555555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lnSpc>
                        <a:spcPts val="1400"/>
                      </a:lnSpc>
                      <a:defRPr lang="ja-JP"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ja-JP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-0.0012x + 0.5774</a:t>
                    </a:r>
                    <a:br>
                      <a:rPr lang="en-US" altLang="ja-JP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ja-JP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= 0.026</a:t>
                    </a:r>
                    <a:endPara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lnSpc>
                      <a:spcPts val="1400"/>
                    </a:lnSpc>
                    <a:defRPr lang="ja-JP"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8!$B$2:$B$32</c:f>
              <c:numCache>
                <c:formatCode>0.0_);[Red]\(0.0\)</c:formatCode>
                <c:ptCount val="31"/>
                <c:pt idx="1">
                  <c:v>3</c:v>
                </c:pt>
                <c:pt idx="2">
                  <c:v>3</c:v>
                </c:pt>
                <c:pt idx="3">
                  <c:v>2.5</c:v>
                </c:pt>
                <c:pt idx="4">
                  <c:v>4</c:v>
                </c:pt>
                <c:pt idx="5">
                  <c:v>4</c:v>
                </c:pt>
                <c:pt idx="6">
                  <c:v>4.5</c:v>
                </c:pt>
                <c:pt idx="7">
                  <c:v>3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7</c:v>
                </c:pt>
                <c:pt idx="18">
                  <c:v>8</c:v>
                </c:pt>
                <c:pt idx="19">
                  <c:v>10</c:v>
                </c:pt>
                <c:pt idx="20">
                  <c:v>10</c:v>
                </c:pt>
                <c:pt idx="21">
                  <c:v>12</c:v>
                </c:pt>
                <c:pt idx="22">
                  <c:v>14</c:v>
                </c:pt>
                <c:pt idx="23">
                  <c:v>15</c:v>
                </c:pt>
                <c:pt idx="24">
                  <c:v>15</c:v>
                </c:pt>
                <c:pt idx="25">
                  <c:v>15</c:v>
                </c:pt>
                <c:pt idx="26">
                  <c:v>20</c:v>
                </c:pt>
                <c:pt idx="27">
                  <c:v>20</c:v>
                </c:pt>
              </c:numCache>
            </c:numRef>
          </c:xVal>
          <c:yVal>
            <c:numRef>
              <c:f>Sheet8!$C$2:$C$32</c:f>
              <c:numCache>
                <c:formatCode>General</c:formatCode>
                <c:ptCount val="31"/>
                <c:pt idx="1">
                  <c:v>1.37</c:v>
                </c:pt>
                <c:pt idx="2">
                  <c:v>0.50170000000000003</c:v>
                </c:pt>
                <c:pt idx="3">
                  <c:v>0.99819999999999998</c:v>
                </c:pt>
                <c:pt idx="4">
                  <c:v>0.26989999999999997</c:v>
                </c:pt>
                <c:pt idx="5">
                  <c:v>0.441</c:v>
                </c:pt>
                <c:pt idx="6">
                  <c:v>0.55830000000000002</c:v>
                </c:pt>
                <c:pt idx="7">
                  <c:v>0.32029999999999997</c:v>
                </c:pt>
                <c:pt idx="8">
                  <c:v>0.42330000000000001</c:v>
                </c:pt>
                <c:pt idx="9">
                  <c:v>0.51780000000000004</c:v>
                </c:pt>
                <c:pt idx="10">
                  <c:v>0.71</c:v>
                </c:pt>
                <c:pt idx="11">
                  <c:v>0.6925</c:v>
                </c:pt>
                <c:pt idx="12">
                  <c:v>0.39279999999999998</c:v>
                </c:pt>
                <c:pt idx="13">
                  <c:v>0.39200000000000002</c:v>
                </c:pt>
                <c:pt idx="14">
                  <c:v>0.46110000000000001</c:v>
                </c:pt>
                <c:pt idx="15">
                  <c:v>0.43369999999999997</c:v>
                </c:pt>
                <c:pt idx="16">
                  <c:v>0.47060000000000002</c:v>
                </c:pt>
                <c:pt idx="17">
                  <c:v>0.41360000000000002</c:v>
                </c:pt>
                <c:pt idx="18">
                  <c:v>0.74519999999999997</c:v>
                </c:pt>
                <c:pt idx="19">
                  <c:v>0.81379999999999997</c:v>
                </c:pt>
                <c:pt idx="20">
                  <c:v>0.53400000000000003</c:v>
                </c:pt>
                <c:pt idx="21">
                  <c:v>0.37740000000000001</c:v>
                </c:pt>
                <c:pt idx="22">
                  <c:v>0.67400000000000004</c:v>
                </c:pt>
                <c:pt idx="23">
                  <c:v>0.45879999999999999</c:v>
                </c:pt>
                <c:pt idx="24">
                  <c:v>0.51570000000000005</c:v>
                </c:pt>
                <c:pt idx="25">
                  <c:v>0.50700000000000001</c:v>
                </c:pt>
                <c:pt idx="26">
                  <c:v>0.75090000000000001</c:v>
                </c:pt>
                <c:pt idx="27">
                  <c:v>0.5873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102-4958-940F-D32403ECC8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1472248"/>
        <c:axId val="239952080"/>
      </c:scatterChart>
      <c:valAx>
        <c:axId val="241472248"/>
        <c:scaling>
          <c:orientation val="minMax"/>
          <c:max val="20"/>
        </c:scaling>
        <c:delete val="1"/>
        <c:axPos val="b"/>
        <c:numFmt formatCode="0.0_);[Red]\(0.0\)" sourceLinked="1"/>
        <c:majorTickMark val="out"/>
        <c:minorTickMark val="none"/>
        <c:tickLblPos val="nextTo"/>
        <c:crossAx val="239952080"/>
        <c:crosses val="autoZero"/>
        <c:crossBetween val="midCat"/>
      </c:valAx>
      <c:valAx>
        <c:axId val="239952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41472248"/>
        <c:crosses val="autoZero"/>
        <c:crossBetween val="midCat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292161339421611"/>
          <c:y val="8.4270975056689346E-2"/>
          <c:w val="0.76875266362252659"/>
          <c:h val="0.8314580498866213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1.8480593607305893E-2"/>
                  <c:y val="-0.5522460317460317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baseline="0" dirty="0"/>
                      <a:t>y = 0.0442x + 19.19</a:t>
                    </a:r>
                    <a:br>
                      <a:rPr lang="en-US" baseline="0" dirty="0"/>
                    </a:br>
                    <a:r>
                      <a:rPr lang="en-US" baseline="0" dirty="0"/>
                      <a:t>r = 0.022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5!$B$3:$B$29</c:f>
              <c:numCache>
                <c:formatCode>0.0_);[Red]\(0.0\)</c:formatCode>
                <c:ptCount val="27"/>
                <c:pt idx="0">
                  <c:v>3</c:v>
                </c:pt>
                <c:pt idx="1">
                  <c:v>3</c:v>
                </c:pt>
                <c:pt idx="2">
                  <c:v>2.5</c:v>
                </c:pt>
                <c:pt idx="3">
                  <c:v>4</c:v>
                </c:pt>
                <c:pt idx="4">
                  <c:v>4</c:v>
                </c:pt>
                <c:pt idx="5">
                  <c:v>4.5</c:v>
                </c:pt>
                <c:pt idx="6">
                  <c:v>3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8</c:v>
                </c:pt>
                <c:pt idx="18">
                  <c:v>10</c:v>
                </c:pt>
                <c:pt idx="19">
                  <c:v>10</c:v>
                </c:pt>
                <c:pt idx="20">
                  <c:v>12</c:v>
                </c:pt>
                <c:pt idx="21">
                  <c:v>14</c:v>
                </c:pt>
                <c:pt idx="22">
                  <c:v>15</c:v>
                </c:pt>
                <c:pt idx="23">
                  <c:v>15</c:v>
                </c:pt>
                <c:pt idx="24">
                  <c:v>15</c:v>
                </c:pt>
                <c:pt idx="25">
                  <c:v>20</c:v>
                </c:pt>
                <c:pt idx="26">
                  <c:v>20</c:v>
                </c:pt>
              </c:numCache>
            </c:numRef>
          </c:xVal>
          <c:yVal>
            <c:numRef>
              <c:f>Sheet5!$C$3:$C$29</c:f>
              <c:numCache>
                <c:formatCode>General</c:formatCode>
                <c:ptCount val="27"/>
                <c:pt idx="0">
                  <c:v>15.4</c:v>
                </c:pt>
                <c:pt idx="1">
                  <c:v>4.2</c:v>
                </c:pt>
                <c:pt idx="2">
                  <c:v>25</c:v>
                </c:pt>
                <c:pt idx="3">
                  <c:v>15.4</c:v>
                </c:pt>
                <c:pt idx="4">
                  <c:v>18.8</c:v>
                </c:pt>
                <c:pt idx="5">
                  <c:v>18.8</c:v>
                </c:pt>
                <c:pt idx="6">
                  <c:v>41.2</c:v>
                </c:pt>
                <c:pt idx="7">
                  <c:v>14.3</c:v>
                </c:pt>
                <c:pt idx="8">
                  <c:v>16.7</c:v>
                </c:pt>
                <c:pt idx="9">
                  <c:v>18.2</c:v>
                </c:pt>
                <c:pt idx="10">
                  <c:v>10</c:v>
                </c:pt>
                <c:pt idx="11">
                  <c:v>27.8</c:v>
                </c:pt>
                <c:pt idx="12">
                  <c:v>50</c:v>
                </c:pt>
                <c:pt idx="13">
                  <c:v>18.2</c:v>
                </c:pt>
                <c:pt idx="14">
                  <c:v>25</c:v>
                </c:pt>
                <c:pt idx="15">
                  <c:v>16.7</c:v>
                </c:pt>
                <c:pt idx="16">
                  <c:v>23.5</c:v>
                </c:pt>
                <c:pt idx="17">
                  <c:v>0</c:v>
                </c:pt>
                <c:pt idx="18">
                  <c:v>15.4</c:v>
                </c:pt>
                <c:pt idx="19">
                  <c:v>14.3</c:v>
                </c:pt>
                <c:pt idx="20">
                  <c:v>10</c:v>
                </c:pt>
                <c:pt idx="21">
                  <c:v>30</c:v>
                </c:pt>
                <c:pt idx="22">
                  <c:v>9.1</c:v>
                </c:pt>
                <c:pt idx="23">
                  <c:v>26.3</c:v>
                </c:pt>
                <c:pt idx="24">
                  <c:v>18.2</c:v>
                </c:pt>
                <c:pt idx="25">
                  <c:v>27.3</c:v>
                </c:pt>
                <c:pt idx="26">
                  <c:v>18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BC7-49F5-9FD2-93B7D16729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9331840"/>
        <c:axId val="239394800"/>
      </c:scatterChart>
      <c:valAx>
        <c:axId val="259331840"/>
        <c:scaling>
          <c:orientation val="minMax"/>
          <c:max val="20"/>
          <c:min val="0"/>
        </c:scaling>
        <c:delete val="1"/>
        <c:axPos val="b"/>
        <c:numFmt formatCode="0.0_);[Red]\(0.0\)" sourceLinked="1"/>
        <c:majorTickMark val="none"/>
        <c:minorTickMark val="none"/>
        <c:tickLblPos val="nextTo"/>
        <c:crossAx val="239394800"/>
        <c:crosses val="autoZero"/>
        <c:crossBetween val="midCat"/>
      </c:valAx>
      <c:valAx>
        <c:axId val="239394800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93318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9.3706597222222215E-2"/>
                  <c:y val="-0.4987228009259259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ja-JP" b="0" baseline="0" dirty="0"/>
                      <a:t>y = -0.2848x + 9.9031</a:t>
                    </a:r>
                  </a:p>
                  <a:p>
                    <a:pPr>
                      <a:defRPr lang="ja-JP" b="0"/>
                    </a:pPr>
                    <a:r>
                      <a:rPr lang="en-US" altLang="ja-JP" b="0" baseline="0" dirty="0"/>
                      <a:t>r = -0.486</a:t>
                    </a:r>
                  </a:p>
                  <a:p>
                    <a:pPr>
                      <a:defRPr lang="ja-JP" b="0"/>
                    </a:pPr>
                    <a:endParaRPr lang="en-US" altLang="ja-JP" b="0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9!$B$3:$B$29</c:f>
              <c:numCache>
                <c:formatCode>0.0_);[Red]\(0.0\)</c:formatCode>
                <c:ptCount val="27"/>
                <c:pt idx="0">
                  <c:v>3</c:v>
                </c:pt>
                <c:pt idx="1">
                  <c:v>3</c:v>
                </c:pt>
                <c:pt idx="2">
                  <c:v>2.5</c:v>
                </c:pt>
                <c:pt idx="3">
                  <c:v>4</c:v>
                </c:pt>
                <c:pt idx="4">
                  <c:v>4</c:v>
                </c:pt>
                <c:pt idx="5">
                  <c:v>4.5</c:v>
                </c:pt>
                <c:pt idx="6">
                  <c:v>3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8</c:v>
                </c:pt>
                <c:pt idx="18">
                  <c:v>10</c:v>
                </c:pt>
                <c:pt idx="19">
                  <c:v>10</c:v>
                </c:pt>
                <c:pt idx="20">
                  <c:v>12</c:v>
                </c:pt>
                <c:pt idx="21">
                  <c:v>14</c:v>
                </c:pt>
                <c:pt idx="22">
                  <c:v>15</c:v>
                </c:pt>
                <c:pt idx="23">
                  <c:v>15</c:v>
                </c:pt>
                <c:pt idx="24">
                  <c:v>15</c:v>
                </c:pt>
                <c:pt idx="25">
                  <c:v>20</c:v>
                </c:pt>
                <c:pt idx="26">
                  <c:v>20</c:v>
                </c:pt>
              </c:numCache>
            </c:numRef>
          </c:xVal>
          <c:yVal>
            <c:numRef>
              <c:f>Sheet9!$C$3:$C$29</c:f>
              <c:numCache>
                <c:formatCode>General</c:formatCode>
                <c:ptCount val="27"/>
                <c:pt idx="0">
                  <c:v>13.247</c:v>
                </c:pt>
                <c:pt idx="1">
                  <c:v>18.885999999999999</c:v>
                </c:pt>
                <c:pt idx="2">
                  <c:v>12.579000000000001</c:v>
                </c:pt>
                <c:pt idx="3">
                  <c:v>8.4749999999999996</c:v>
                </c:pt>
                <c:pt idx="4">
                  <c:v>9.0760000000000005</c:v>
                </c:pt>
                <c:pt idx="5">
                  <c:v>7.8410000000000002</c:v>
                </c:pt>
                <c:pt idx="6">
                  <c:v>6.64</c:v>
                </c:pt>
                <c:pt idx="7">
                  <c:v>6.0730000000000004</c:v>
                </c:pt>
                <c:pt idx="8">
                  <c:v>8.3079999999999998</c:v>
                </c:pt>
                <c:pt idx="9">
                  <c:v>7.7409999999999997</c:v>
                </c:pt>
                <c:pt idx="10">
                  <c:v>7.641</c:v>
                </c:pt>
                <c:pt idx="11">
                  <c:v>6.6070000000000002</c:v>
                </c:pt>
                <c:pt idx="12">
                  <c:v>5.7720000000000002</c:v>
                </c:pt>
                <c:pt idx="13">
                  <c:v>5.4390000000000001</c:v>
                </c:pt>
                <c:pt idx="14">
                  <c:v>4.6379999999999999</c:v>
                </c:pt>
                <c:pt idx="15">
                  <c:v>6.2729999999999997</c:v>
                </c:pt>
                <c:pt idx="16">
                  <c:v>6.64</c:v>
                </c:pt>
                <c:pt idx="17">
                  <c:v>6.8070000000000004</c:v>
                </c:pt>
                <c:pt idx="18">
                  <c:v>7.641</c:v>
                </c:pt>
                <c:pt idx="19">
                  <c:v>6.54</c:v>
                </c:pt>
                <c:pt idx="20">
                  <c:v>6.44</c:v>
                </c:pt>
                <c:pt idx="21">
                  <c:v>5.1719999999999997</c:v>
                </c:pt>
                <c:pt idx="22">
                  <c:v>5.4050000000000002</c:v>
                </c:pt>
                <c:pt idx="23">
                  <c:v>5.6390000000000002</c:v>
                </c:pt>
                <c:pt idx="24">
                  <c:v>5.4390000000000001</c:v>
                </c:pt>
                <c:pt idx="25">
                  <c:v>7.274</c:v>
                </c:pt>
                <c:pt idx="26">
                  <c:v>5.506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713-4CB4-B68C-D2710891C4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7663808"/>
        <c:axId val="237661456"/>
      </c:scatterChart>
      <c:valAx>
        <c:axId val="237663808"/>
        <c:scaling>
          <c:orientation val="minMax"/>
          <c:max val="20"/>
        </c:scaling>
        <c:delete val="1"/>
        <c:axPos val="b"/>
        <c:numFmt formatCode="0.0_);[Red]\(0.0\)" sourceLinked="1"/>
        <c:majorTickMark val="out"/>
        <c:minorTickMark val="none"/>
        <c:tickLblPos val="nextTo"/>
        <c:crossAx val="237661456"/>
        <c:crosses val="autoZero"/>
        <c:crossBetween val="midCat"/>
      </c:valAx>
      <c:valAx>
        <c:axId val="237661456"/>
        <c:scaling>
          <c:orientation val="minMax"/>
          <c:max val="20"/>
        </c:scaling>
        <c:delete val="1"/>
        <c:axPos val="l"/>
        <c:numFmt formatCode="General" sourceLinked="1"/>
        <c:majorTickMark val="out"/>
        <c:minorTickMark val="none"/>
        <c:tickLblPos val="nextTo"/>
        <c:crossAx val="237663808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53F416-8676-458E-AC05-AE1EFB497A2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E556D5-B5E2-4D78-AF83-A04B36A4E8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53064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400" dirty="0">
                <a:solidFill>
                  <a:srgbClr val="FF0000"/>
                </a:solidFill>
              </a:rPr>
              <a:t>The reviewer instructed</a:t>
            </a:r>
            <a:r>
              <a:rPr lang="en-US" sz="1400" baseline="0" dirty="0">
                <a:solidFill>
                  <a:srgbClr val="FF0000"/>
                </a:solidFill>
              </a:rPr>
              <a:t> that Supplementary Fig 1 should be inserted in the manuscript as Fig 1</a:t>
            </a:r>
          </a:p>
          <a:p>
            <a:endParaRPr lang="en-ZA" sz="1400" dirty="0">
              <a:solidFill>
                <a:srgbClr val="FF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E556D5-B5E2-4D78-AF83-A04B36A4E88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00050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E20221-DBF8-4231-A8AB-ABF1E83954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141519B-18A9-4E1E-8869-B01A5042E0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C5D44A-2B61-4EE1-BB8F-DCB8DB1D4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FE4E3D-F41D-4F0D-96FA-D5864EF90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0BFFAF5-74FF-4D3A-9CC3-60F7FBC5A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5155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834F0D-0259-4B53-ADDA-931E693066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254FE5-A4E3-445F-BB4C-61DD4CB8E6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63181B-6FFB-477B-9982-AAD42EA7E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4D4AC4-A11A-4A7A-98BB-F2F6945E1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FD882C3-6495-4AA3-9C50-A0348DE6F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962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41B4433-4EBA-40F6-A1B2-50A06A05D4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A9862AA-8A01-409E-8386-F75F0EB318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21969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EE95B-5A1F-4F6F-9C5A-3844F92C8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CF2ED2-F3EC-43A1-800C-DC1BAF166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5AC5A0-C0C5-4579-ABE4-E580B9BE2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43843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80651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82062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42513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14474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8795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04929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12739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439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A0535A-A182-4115-BB48-76ABEA1165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5EA9448-31C2-4D70-9D37-35AED23E5E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A312DC-CDD4-4F13-A82C-18A45C00F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5FA3C7-6A92-43DF-B4FC-2AAE904C8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358947-F94F-471C-AECE-CD6676722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692896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53829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48823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810737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1EBE3B-460B-4D14-B3BB-D7BE196C57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54981A2-EE6C-48EB-A7A2-40DB89C3D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A8F9666-6FC5-4D30-B635-C03DD89E3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D868914-870A-4CE0-B536-48D5AB955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8552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F186BA-5FE8-4CEE-9238-8BE41330A9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191DDB3-C5CD-4E25-A5B3-80768CAEF6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F498A5-1667-41BE-A93A-215993662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2A24E0-AC34-4BCB-94BD-DCDAC3551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621590-5356-4045-ADDA-0A2A9724D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4063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53EECE-80BD-435F-8DE9-8EB3AAF328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AC8C508-E26E-49C1-8E66-DE7541D4A2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7" y="2434167"/>
            <a:ext cx="2900363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18251F0-4554-4604-88F9-4E8A89C963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86150" y="2434167"/>
            <a:ext cx="2900363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BA530F6-F909-491D-86B6-9EA0F07AC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299866-23AB-4827-844B-0C527ABF3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D6CEC84-6CC2-4DB2-88AA-C573BF42E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323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82607F-210F-4311-82C2-5332D00276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679" y="486834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4B4D0F3-F28E-4B31-87C6-809D301F6D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679" y="2241551"/>
            <a:ext cx="290155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977B948-D822-401E-B083-523CFE0596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679" y="3340100"/>
            <a:ext cx="290155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44C40FE-A56F-4C61-844A-D144B0319F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841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A6F892A-5179-4F21-B88C-0410A685DF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841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A98E4E7-071A-458A-A2A1-BAC179704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6A2D260-FC00-4B06-B7D3-D210C4F1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7F457C9-0E0A-437E-BC7D-26A8F5E76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0762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2788FC-F999-4798-9AD9-25448FCDA8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9C477A0-7A20-408E-B7E3-EAB6A3C91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1DCFAE0-10B5-4A46-8314-7A1F990CB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BE77927-40F1-4FEE-A926-FD8BBA95E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3090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6A46F65-8334-4663-ACE2-B002FB65B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A373199-02ED-413D-8AE2-B02362596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1E6CFDA-4EEB-494A-8BFD-1A3C4DDD2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5892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A5130A-7712-4D26-8139-4F0A0AE4D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679" y="609600"/>
            <a:ext cx="2212181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0D2D817-5B72-44ED-B3C2-0F3CDC9CDD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841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3235628-E965-4453-80BF-B3DFC84968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679" y="2743200"/>
            <a:ext cx="2212181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25D535E-02B6-43DE-ABF5-5C57378FB0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F39FD4B-CB3B-4DC5-AE09-170613156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A282C1E-5C57-4996-BF7D-DE90BB198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129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4D701E-DF9C-4B8F-B327-DA4301E01E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679" y="609600"/>
            <a:ext cx="2212181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A522E08-8F13-491F-BF54-F571FA688F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841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C390675-D569-438E-9FB6-F5C0BEA7AD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679" y="2743200"/>
            <a:ext cx="2212181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7F70C5-C753-4CF5-9ECA-05568C98A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47462AB-FE0D-4CE1-89A3-2284B98B4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CDFCE0-3CF1-475E-B11C-000A3AA13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26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92E445C-A603-4CC1-AEA2-1A50924FE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05800E-87E9-425C-BDE5-E73925ED07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4234C0-95DF-447D-9BFC-EAB385013F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147E47-4652-4DF8-A626-C7877EAAC578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58A1DF-75FC-447C-ACB8-6DB139C738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B6F0A6-BA4F-4FEE-806F-5E7C135BC7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72709-8D53-4A64-82C0-C5FD73FD3B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912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210C26-5467-4704-8C35-D7F601258A47}" type="datetimeFigureOut">
              <a:rPr kumimoji="1" lang="ja-JP" altLang="en-US" smtClean="0"/>
              <a:t>2022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23439-524A-4270-BD35-1DF2AC7DD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7440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6" r:id="rId1"/>
    <p:sldLayoutId id="2147483687" r:id="rId2"/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  <p:sldLayoutId id="2147483672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3A85C9F5-9EEA-4D86-A723-23A26288F64B}"/>
              </a:ext>
            </a:extLst>
          </p:cNvPr>
          <p:cNvGrpSpPr/>
          <p:nvPr/>
        </p:nvGrpSpPr>
        <p:grpSpPr>
          <a:xfrm>
            <a:off x="3429000" y="538165"/>
            <a:ext cx="3177117" cy="2495386"/>
            <a:chOff x="3429000" y="1199902"/>
            <a:chExt cx="3177117" cy="2495386"/>
          </a:xfrm>
        </p:grpSpPr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96D69488-7A97-4584-9ECB-35C82C27157B}"/>
                </a:ext>
              </a:extLst>
            </p:cNvPr>
            <p:cNvGrpSpPr/>
            <p:nvPr/>
          </p:nvGrpSpPr>
          <p:grpSpPr>
            <a:xfrm>
              <a:off x="3429000" y="1199902"/>
              <a:ext cx="3019872" cy="2264483"/>
              <a:chOff x="3554469" y="4098534"/>
              <a:chExt cx="3019872" cy="2264483"/>
            </a:xfrm>
          </p:grpSpPr>
          <p:grpSp>
            <p:nvGrpSpPr>
              <p:cNvPr id="28" name="グループ化 27">
                <a:extLst>
                  <a:ext uri="{FF2B5EF4-FFF2-40B4-BE49-F238E27FC236}">
                    <a16:creationId xmlns:a16="http://schemas.microsoft.com/office/drawing/2014/main" id="{1274BCFC-AFE7-4E3A-85BE-F748FFB5D82A}"/>
                  </a:ext>
                </a:extLst>
              </p:cNvPr>
              <p:cNvGrpSpPr/>
              <p:nvPr/>
            </p:nvGrpSpPr>
            <p:grpSpPr>
              <a:xfrm>
                <a:off x="3587840" y="4347017"/>
                <a:ext cx="2986501" cy="2016000"/>
                <a:chOff x="2541249" y="3561295"/>
                <a:chExt cx="3432765" cy="2103393"/>
              </a:xfrm>
            </p:grpSpPr>
            <p:graphicFrame>
              <p:nvGraphicFramePr>
                <p:cNvPr id="30" name="グラフ 29">
                  <a:extLst>
                    <a:ext uri="{FF2B5EF4-FFF2-40B4-BE49-F238E27FC236}">
                      <a16:creationId xmlns:a16="http://schemas.microsoft.com/office/drawing/2014/main" id="{0E2B7EF9-27CB-41EF-9674-7A56C07F1DB1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2746425" y="3561295"/>
                <a:ext cx="3227589" cy="210339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7C9C2CB1-04F9-48C6-9B59-2676437E07F0}"/>
                    </a:ext>
                  </a:extLst>
                </p:cNvPr>
                <p:cNvSpPr txBox="1"/>
                <p:nvPr/>
              </p:nvSpPr>
              <p:spPr>
                <a:xfrm rot="16200000">
                  <a:off x="1846726" y="4306390"/>
                  <a:ext cx="1666063" cy="27701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otation Saccade</a:t>
                  </a:r>
                  <a:r>
                    <a:rPr lang="ja-JP" alt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</a:t>
                  </a:r>
                  <a:endParaRPr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39B5DC9B-A91C-4C04-90DB-1543E8D7B7EF}"/>
                  </a:ext>
                </a:extLst>
              </p:cNvPr>
              <p:cNvSpPr txBox="1"/>
              <p:nvPr/>
            </p:nvSpPr>
            <p:spPr>
              <a:xfrm>
                <a:off x="3554469" y="4098534"/>
                <a:ext cx="36188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400" b="1" dirty="0">
                    <a:effectLst/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0F2EAB74-5A8E-4834-B636-4545E76C8F3D}"/>
                </a:ext>
              </a:extLst>
            </p:cNvPr>
            <p:cNvSpPr txBox="1"/>
            <p:nvPr/>
          </p:nvSpPr>
          <p:spPr>
            <a:xfrm>
              <a:off x="4197798" y="3418289"/>
              <a:ext cx="22334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I/4central visual field (degree)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462918EE-B645-479E-BE2F-E7FD146C6D22}"/>
                </a:ext>
              </a:extLst>
            </p:cNvPr>
            <p:cNvSpPr txBox="1"/>
            <p:nvPr/>
          </p:nvSpPr>
          <p:spPr>
            <a:xfrm>
              <a:off x="4349789" y="1640537"/>
              <a:ext cx="2256328" cy="4142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>
                <a:lnSpc>
                  <a:spcPts val="1200"/>
                </a:lnSpc>
                <a:defRPr sz="16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200" baseline="0" dirty="0">
                  <a:latin typeface="Arial" panose="020B0604020202020204" pitchFamily="34" charset="0"/>
                  <a:cs typeface="Arial" panose="020B0604020202020204" pitchFamily="34" charset="0"/>
                </a:rPr>
                <a:t>y = -1.6942x + 34.921</a:t>
              </a:r>
              <a:br>
                <a:rPr lang="en-US" altLang="ja-JP" sz="1200" baseline="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ja-JP" sz="1200" baseline="0" dirty="0">
                  <a:latin typeface="Arial" panose="020B0604020202020204" pitchFamily="34" charset="0"/>
                  <a:cs typeface="Arial" panose="020B0604020202020204" pitchFamily="34" charset="0"/>
                </a:rPr>
                <a:t>r= -0.317</a:t>
              </a: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4D19249-DC34-46AC-B48F-A74041517504}"/>
              </a:ext>
            </a:extLst>
          </p:cNvPr>
          <p:cNvGrpSpPr/>
          <p:nvPr/>
        </p:nvGrpSpPr>
        <p:grpSpPr>
          <a:xfrm>
            <a:off x="381751" y="3279937"/>
            <a:ext cx="3150391" cy="2477778"/>
            <a:chOff x="381751" y="3279937"/>
            <a:chExt cx="3150391" cy="2477778"/>
          </a:xfrm>
        </p:grpSpPr>
        <p:graphicFrame>
          <p:nvGraphicFramePr>
            <p:cNvPr id="32" name="グラフ 31">
              <a:extLst>
                <a:ext uri="{FF2B5EF4-FFF2-40B4-BE49-F238E27FC236}">
                  <a16:creationId xmlns:a16="http://schemas.microsoft.com/office/drawing/2014/main" id="{0A442250-4154-4736-8132-34521297618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22804398"/>
                </p:ext>
              </p:extLst>
            </p:nvPr>
          </p:nvGraphicFramePr>
          <p:xfrm>
            <a:off x="655284" y="3601351"/>
            <a:ext cx="2484000" cy="172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36" name="グループ化 35">
              <a:extLst>
                <a:ext uri="{FF2B5EF4-FFF2-40B4-BE49-F238E27FC236}">
                  <a16:creationId xmlns:a16="http://schemas.microsoft.com/office/drawing/2014/main" id="{DBD78029-AAB3-42A6-9F9F-044276BC3E65}"/>
                </a:ext>
              </a:extLst>
            </p:cNvPr>
            <p:cNvGrpSpPr/>
            <p:nvPr/>
          </p:nvGrpSpPr>
          <p:grpSpPr>
            <a:xfrm>
              <a:off x="937471" y="3749139"/>
              <a:ext cx="2594671" cy="2008576"/>
              <a:chOff x="-1552725" y="2370429"/>
              <a:chExt cx="2594671" cy="2008576"/>
            </a:xfrm>
          </p:grpSpPr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234FB18B-3C38-4B2E-BF60-414E4747E330}"/>
                  </a:ext>
                </a:extLst>
              </p:cNvPr>
              <p:cNvSpPr txBox="1"/>
              <p:nvPr/>
            </p:nvSpPr>
            <p:spPr>
              <a:xfrm>
                <a:off x="-1552725" y="3831426"/>
                <a:ext cx="24452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 </a:t>
                </a:r>
                <a:r>
                  <a:rPr kumimoji="1" lang="en-US" altLang="ja-JP" sz="1200" spc="-15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         10      </a:t>
                </a:r>
                <a:r>
                  <a:rPr kumimoji="1" lang="en-US" altLang="ja-JP" sz="1200" spc="-15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kumimoji="1" lang="en-US" altLang="ja-JP" sz="1050" spc="-15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5    </a:t>
                </a:r>
                <a:r>
                  <a:rPr kumimoji="1" lang="en-US" altLang="ja-JP" sz="1200" spc="-15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kumimoji="1" lang="en-US" altLang="ja-JP" sz="12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0" name="グループ化 39">
                <a:extLst>
                  <a:ext uri="{FF2B5EF4-FFF2-40B4-BE49-F238E27FC236}">
                    <a16:creationId xmlns:a16="http://schemas.microsoft.com/office/drawing/2014/main" id="{D29FBAA6-62F9-4081-A726-CF73BE66C8CD}"/>
                  </a:ext>
                </a:extLst>
              </p:cNvPr>
              <p:cNvGrpSpPr/>
              <p:nvPr/>
            </p:nvGrpSpPr>
            <p:grpSpPr>
              <a:xfrm>
                <a:off x="-1448621" y="2370429"/>
                <a:ext cx="79093" cy="1194129"/>
                <a:chOff x="937011" y="2161052"/>
                <a:chExt cx="79093" cy="1194129"/>
              </a:xfrm>
            </p:grpSpPr>
            <p:cxnSp>
              <p:nvCxnSpPr>
                <p:cNvPr id="48" name="直線コネクタ 47">
                  <a:extLst>
                    <a:ext uri="{FF2B5EF4-FFF2-40B4-BE49-F238E27FC236}">
                      <a16:creationId xmlns:a16="http://schemas.microsoft.com/office/drawing/2014/main" id="{43D2C242-7F25-434A-BD9F-E2B9C8A6969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44104" y="2161052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線コネクタ 48">
                  <a:extLst>
                    <a:ext uri="{FF2B5EF4-FFF2-40B4-BE49-F238E27FC236}">
                      <a16:creationId xmlns:a16="http://schemas.microsoft.com/office/drawing/2014/main" id="{989440D2-37A3-4913-88E3-BEC6B8470A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37011" y="2640807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直線コネクタ 49">
                  <a:extLst>
                    <a:ext uri="{FF2B5EF4-FFF2-40B4-BE49-F238E27FC236}">
                      <a16:creationId xmlns:a16="http://schemas.microsoft.com/office/drawing/2014/main" id="{94BFBEEE-8CD2-4D66-AE9D-E3B96FBA3E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44104" y="2878243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直線コネクタ 50">
                  <a:extLst>
                    <a:ext uri="{FF2B5EF4-FFF2-40B4-BE49-F238E27FC236}">
                      <a16:creationId xmlns:a16="http://schemas.microsoft.com/office/drawing/2014/main" id="{7BCF6E84-F958-4333-94A0-263BE26206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37011" y="3119438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直線コネクタ 51">
                  <a:extLst>
                    <a:ext uri="{FF2B5EF4-FFF2-40B4-BE49-F238E27FC236}">
                      <a16:creationId xmlns:a16="http://schemas.microsoft.com/office/drawing/2014/main" id="{DDF4DB85-8E46-408C-A494-30DAC42101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37676" y="3355181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直線コネクタ 54">
                  <a:extLst>
                    <a:ext uri="{FF2B5EF4-FFF2-40B4-BE49-F238E27FC236}">
                      <a16:creationId xmlns:a16="http://schemas.microsoft.com/office/drawing/2014/main" id="{40A61C05-B221-4556-9B37-1660A14F9BA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39669" y="2402682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" name="グループ化 40">
                <a:extLst>
                  <a:ext uri="{FF2B5EF4-FFF2-40B4-BE49-F238E27FC236}">
                    <a16:creationId xmlns:a16="http://schemas.microsoft.com/office/drawing/2014/main" id="{465192E2-5B42-42E6-897E-C838C45C83AF}"/>
                  </a:ext>
                </a:extLst>
              </p:cNvPr>
              <p:cNvGrpSpPr/>
              <p:nvPr/>
            </p:nvGrpSpPr>
            <p:grpSpPr>
              <a:xfrm>
                <a:off x="-1444880" y="3731590"/>
                <a:ext cx="2045368" cy="72000"/>
                <a:chOff x="940752" y="3609663"/>
                <a:chExt cx="2045368" cy="72000"/>
              </a:xfrm>
            </p:grpSpPr>
            <p:cxnSp>
              <p:nvCxnSpPr>
                <p:cNvPr id="43" name="直線コネクタ 42">
                  <a:extLst>
                    <a:ext uri="{FF2B5EF4-FFF2-40B4-BE49-F238E27FC236}">
                      <a16:creationId xmlns:a16="http://schemas.microsoft.com/office/drawing/2014/main" id="{E31763E4-D6E3-41EA-A85D-43B29EB87E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40752" y="3681663"/>
                  <a:ext cx="204536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線コネクタ 43">
                  <a:extLst>
                    <a:ext uri="{FF2B5EF4-FFF2-40B4-BE49-F238E27FC236}">
                      <a16:creationId xmlns:a16="http://schemas.microsoft.com/office/drawing/2014/main" id="{45AD1BDE-3452-4284-9600-D363A3764D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963436" y="3609663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直線コネクタ 44">
                  <a:extLst>
                    <a:ext uri="{FF2B5EF4-FFF2-40B4-BE49-F238E27FC236}">
                      <a16:creationId xmlns:a16="http://schemas.microsoft.com/office/drawing/2014/main" id="{2168B207-F9C0-4FB2-9335-DFB48507284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986120" y="3609663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線コネクタ 45">
                  <a:extLst>
                    <a:ext uri="{FF2B5EF4-FFF2-40B4-BE49-F238E27FC236}">
                      <a16:creationId xmlns:a16="http://schemas.microsoft.com/office/drawing/2014/main" id="{B32BF391-C92D-4CCF-B874-7DDCDC318E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490820" y="3609663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線コネクタ 46">
                  <a:extLst>
                    <a:ext uri="{FF2B5EF4-FFF2-40B4-BE49-F238E27FC236}">
                      <a16:creationId xmlns:a16="http://schemas.microsoft.com/office/drawing/2014/main" id="{6C426864-7906-46E1-86F7-64B15D5D90F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447833" y="3609663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7834AD47-CCFE-49DD-A0BF-332BB84C25FA}"/>
                  </a:ext>
                </a:extLst>
              </p:cNvPr>
              <p:cNvSpPr txBox="1"/>
              <p:nvPr/>
            </p:nvSpPr>
            <p:spPr>
              <a:xfrm>
                <a:off x="-1335997" y="4102006"/>
                <a:ext cx="23779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/4central visual field  (degree)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1CD491DC-BFF6-477D-BB84-3C075CDBD90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1575" y="3749139"/>
              <a:ext cx="0" cy="14331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71172709-E02C-40ED-B232-CEB99129F4CB}"/>
                </a:ext>
              </a:extLst>
            </p:cNvPr>
            <p:cNvSpPr txBox="1"/>
            <p:nvPr/>
          </p:nvSpPr>
          <p:spPr>
            <a:xfrm rot="16200000">
              <a:off x="-331354" y="4116070"/>
              <a:ext cx="1871787" cy="41273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Number of Fixation</a:t>
              </a:r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C843EF5C-894D-4D18-9B5D-CC7604B83C1C}"/>
                </a:ext>
              </a:extLst>
            </p:cNvPr>
            <p:cNvSpPr txBox="1"/>
            <p:nvPr/>
          </p:nvSpPr>
          <p:spPr>
            <a:xfrm>
              <a:off x="381751" y="3279937"/>
              <a:ext cx="36188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132B5A0-AFF8-44BB-9603-CF706DAC8F2D}"/>
              </a:ext>
            </a:extLst>
          </p:cNvPr>
          <p:cNvGrpSpPr/>
          <p:nvPr/>
        </p:nvGrpSpPr>
        <p:grpSpPr>
          <a:xfrm>
            <a:off x="3501932" y="3232653"/>
            <a:ext cx="2976592" cy="2492926"/>
            <a:chOff x="3501932" y="3232653"/>
            <a:chExt cx="2976592" cy="2492926"/>
          </a:xfrm>
        </p:grpSpPr>
        <p:graphicFrame>
          <p:nvGraphicFramePr>
            <p:cNvPr id="57" name="グラフ 56">
              <a:extLst>
                <a:ext uri="{FF2B5EF4-FFF2-40B4-BE49-F238E27FC236}">
                  <a16:creationId xmlns:a16="http://schemas.microsoft.com/office/drawing/2014/main" id="{C9F173BB-0B53-418C-8142-B024182A67D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02159396"/>
                </p:ext>
              </p:extLst>
            </p:nvPr>
          </p:nvGraphicFramePr>
          <p:xfrm>
            <a:off x="3703375" y="3615583"/>
            <a:ext cx="2556000" cy="172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62" name="グループ化 61">
              <a:extLst>
                <a:ext uri="{FF2B5EF4-FFF2-40B4-BE49-F238E27FC236}">
                  <a16:creationId xmlns:a16="http://schemas.microsoft.com/office/drawing/2014/main" id="{E3911B66-780B-4864-90CB-3711C92B64AA}"/>
                </a:ext>
              </a:extLst>
            </p:cNvPr>
            <p:cNvGrpSpPr/>
            <p:nvPr/>
          </p:nvGrpSpPr>
          <p:grpSpPr>
            <a:xfrm>
              <a:off x="4014601" y="3744087"/>
              <a:ext cx="2463923" cy="1981492"/>
              <a:chOff x="-1552725" y="2370429"/>
              <a:chExt cx="2463923" cy="1981492"/>
            </a:xfrm>
          </p:grpSpPr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96D1C83C-7839-4C14-8B2D-1CF93E5CEDC8}"/>
                  </a:ext>
                </a:extLst>
              </p:cNvPr>
              <p:cNvSpPr txBox="1"/>
              <p:nvPr/>
            </p:nvSpPr>
            <p:spPr>
              <a:xfrm>
                <a:off x="-1552725" y="3831426"/>
                <a:ext cx="24452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 </a:t>
                </a:r>
                <a:r>
                  <a:rPr kumimoji="1" lang="en-US" altLang="ja-JP" sz="1200" spc="-15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         10      </a:t>
                </a:r>
                <a:r>
                  <a:rPr kumimoji="1" lang="en-US" altLang="ja-JP" sz="1200" spc="-15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kumimoji="1" lang="en-US" altLang="ja-JP" sz="1050" spc="-15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5    </a:t>
                </a:r>
                <a:r>
                  <a:rPr kumimoji="1" lang="en-US" altLang="ja-JP" sz="1200" spc="-15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kumimoji="1" lang="en-US" altLang="ja-JP" sz="12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5" name="グループ化 64">
                <a:extLst>
                  <a:ext uri="{FF2B5EF4-FFF2-40B4-BE49-F238E27FC236}">
                    <a16:creationId xmlns:a16="http://schemas.microsoft.com/office/drawing/2014/main" id="{3A3CA8D8-D897-4833-BB81-5C0E48DA1D15}"/>
                  </a:ext>
                </a:extLst>
              </p:cNvPr>
              <p:cNvGrpSpPr/>
              <p:nvPr/>
            </p:nvGrpSpPr>
            <p:grpSpPr>
              <a:xfrm>
                <a:off x="-1448621" y="2370429"/>
                <a:ext cx="79093" cy="1079000"/>
                <a:chOff x="937011" y="2161052"/>
                <a:chExt cx="79093" cy="1079000"/>
              </a:xfrm>
            </p:grpSpPr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5558C286-8EE6-4EA1-AAE8-537D3078FD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44104" y="2161052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直線コネクタ 74">
                  <a:extLst>
                    <a:ext uri="{FF2B5EF4-FFF2-40B4-BE49-F238E27FC236}">
                      <a16:creationId xmlns:a16="http://schemas.microsoft.com/office/drawing/2014/main" id="{01A3BFB8-C14B-48E6-845C-7D0D3E7931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44104" y="2878243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直線コネクタ 75">
                  <a:extLst>
                    <a:ext uri="{FF2B5EF4-FFF2-40B4-BE49-F238E27FC236}">
                      <a16:creationId xmlns:a16="http://schemas.microsoft.com/office/drawing/2014/main" id="{2AE4A5BC-7012-4818-BA69-9F01729763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41276" y="3240052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線コネクタ 77">
                  <a:extLst>
                    <a:ext uri="{FF2B5EF4-FFF2-40B4-BE49-F238E27FC236}">
                      <a16:creationId xmlns:a16="http://schemas.microsoft.com/office/drawing/2014/main" id="{4249B90B-4887-4C58-9CDF-F1CD776C58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37011" y="2512220"/>
                  <a:ext cx="72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6" name="グループ化 65">
                <a:extLst>
                  <a:ext uri="{FF2B5EF4-FFF2-40B4-BE49-F238E27FC236}">
                    <a16:creationId xmlns:a16="http://schemas.microsoft.com/office/drawing/2014/main" id="{4E91C1C4-CCED-45C9-B87E-01BB15B635E6}"/>
                  </a:ext>
                </a:extLst>
              </p:cNvPr>
              <p:cNvGrpSpPr/>
              <p:nvPr/>
            </p:nvGrpSpPr>
            <p:grpSpPr>
              <a:xfrm>
                <a:off x="-1444880" y="3731590"/>
                <a:ext cx="2045368" cy="72000"/>
                <a:chOff x="940752" y="3609663"/>
                <a:chExt cx="2045368" cy="72000"/>
              </a:xfrm>
            </p:grpSpPr>
            <p:cxnSp>
              <p:nvCxnSpPr>
                <p:cNvPr id="68" name="直線コネクタ 67">
                  <a:extLst>
                    <a:ext uri="{FF2B5EF4-FFF2-40B4-BE49-F238E27FC236}">
                      <a16:creationId xmlns:a16="http://schemas.microsoft.com/office/drawing/2014/main" id="{4226693D-69A4-4101-818C-15C4174419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40752" y="3681663"/>
                  <a:ext cx="204536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直線コネクタ 68">
                  <a:extLst>
                    <a:ext uri="{FF2B5EF4-FFF2-40B4-BE49-F238E27FC236}">
                      <a16:creationId xmlns:a16="http://schemas.microsoft.com/office/drawing/2014/main" id="{7317B3DF-CB8D-4C7B-B27F-4BE7560AD56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963436" y="3609663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直線コネクタ 69">
                  <a:extLst>
                    <a:ext uri="{FF2B5EF4-FFF2-40B4-BE49-F238E27FC236}">
                      <a16:creationId xmlns:a16="http://schemas.microsoft.com/office/drawing/2014/main" id="{7998F7F4-4360-47E0-949E-42CECF9E2EC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986120" y="3609663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直線コネクタ 70">
                  <a:extLst>
                    <a:ext uri="{FF2B5EF4-FFF2-40B4-BE49-F238E27FC236}">
                      <a16:creationId xmlns:a16="http://schemas.microsoft.com/office/drawing/2014/main" id="{6E255F74-9F8C-42EB-BFF0-0DA83742B2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476533" y="3609663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直線コネクタ 71">
                  <a:extLst>
                    <a:ext uri="{FF2B5EF4-FFF2-40B4-BE49-F238E27FC236}">
                      <a16:creationId xmlns:a16="http://schemas.microsoft.com/office/drawing/2014/main" id="{0523F0EB-59CD-4811-98B8-7FB37F305D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447833" y="3609663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15CD0808-1E14-460F-AFC1-6630BE911713}"/>
                  </a:ext>
                </a:extLst>
              </p:cNvPr>
              <p:cNvSpPr txBox="1"/>
              <p:nvPr/>
            </p:nvSpPr>
            <p:spPr>
              <a:xfrm>
                <a:off x="-1405528" y="4074922"/>
                <a:ext cx="23167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/4central visual field  (degree)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E374A7ED-9061-4E05-896D-6384A894D0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25798" y="3740104"/>
              <a:ext cx="0" cy="14331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736F9F5-6FC9-4AB0-A4F7-F5A05719E183}"/>
                </a:ext>
              </a:extLst>
            </p:cNvPr>
            <p:cNvSpPr txBox="1"/>
            <p:nvPr/>
          </p:nvSpPr>
          <p:spPr>
            <a:xfrm rot="16200000">
              <a:off x="2802616" y="4154568"/>
              <a:ext cx="1871787" cy="41273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Duration of Fixation</a:t>
              </a:r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AF0727F5-5AC2-4A1A-9A71-06BBF21427B5}"/>
                </a:ext>
              </a:extLst>
            </p:cNvPr>
            <p:cNvSpPr txBox="1"/>
            <p:nvPr/>
          </p:nvSpPr>
          <p:spPr>
            <a:xfrm>
              <a:off x="3501932" y="3232653"/>
              <a:ext cx="36188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D</a:t>
              </a:r>
            </a:p>
          </p:txBody>
        </p:sp>
      </p:grp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A1D2701B-64EA-41A1-865C-85F8B445CEC3}"/>
              </a:ext>
            </a:extLst>
          </p:cNvPr>
          <p:cNvGrpSpPr/>
          <p:nvPr/>
        </p:nvGrpSpPr>
        <p:grpSpPr>
          <a:xfrm>
            <a:off x="391810" y="574502"/>
            <a:ext cx="3166526" cy="2465268"/>
            <a:chOff x="391810" y="1236239"/>
            <a:chExt cx="3166526" cy="2465268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9A2F5810-8861-471C-B0F1-5C9828C17277}"/>
                </a:ext>
              </a:extLst>
            </p:cNvPr>
            <p:cNvGrpSpPr/>
            <p:nvPr/>
          </p:nvGrpSpPr>
          <p:grpSpPr>
            <a:xfrm>
              <a:off x="401695" y="1323473"/>
              <a:ext cx="3156641" cy="2378034"/>
              <a:chOff x="465400" y="1639609"/>
              <a:chExt cx="3156641" cy="2378034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CE847AAC-AABD-485F-A6DB-6E623A8D059D}"/>
                  </a:ext>
                </a:extLst>
              </p:cNvPr>
              <p:cNvGrpSpPr/>
              <p:nvPr/>
            </p:nvGrpSpPr>
            <p:grpSpPr>
              <a:xfrm>
                <a:off x="597729" y="1842864"/>
                <a:ext cx="3024312" cy="2174779"/>
                <a:chOff x="750668" y="2422818"/>
                <a:chExt cx="3024312" cy="2174779"/>
              </a:xfrm>
            </p:grpSpPr>
            <p:grpSp>
              <p:nvGrpSpPr>
                <p:cNvPr id="7" name="グループ化 6">
                  <a:extLst>
                    <a:ext uri="{FF2B5EF4-FFF2-40B4-BE49-F238E27FC236}">
                      <a16:creationId xmlns:a16="http://schemas.microsoft.com/office/drawing/2014/main" id="{88F4F9C5-467A-48CD-8B7A-258A9684DC6D}"/>
                    </a:ext>
                  </a:extLst>
                </p:cNvPr>
                <p:cNvGrpSpPr/>
                <p:nvPr/>
              </p:nvGrpSpPr>
              <p:grpSpPr>
                <a:xfrm>
                  <a:off x="1117878" y="2575211"/>
                  <a:ext cx="2657102" cy="2022386"/>
                  <a:chOff x="-1552725" y="2341854"/>
                  <a:chExt cx="2657102" cy="2022386"/>
                </a:xfrm>
              </p:grpSpPr>
              <p:sp>
                <p:nvSpPr>
                  <p:cNvPr id="10" name="テキスト ボックス 9">
                    <a:extLst>
                      <a:ext uri="{FF2B5EF4-FFF2-40B4-BE49-F238E27FC236}">
                        <a16:creationId xmlns:a16="http://schemas.microsoft.com/office/drawing/2014/main" id="{32E3A279-D000-44D3-857A-BB86943F691B}"/>
                      </a:ext>
                    </a:extLst>
                  </p:cNvPr>
                  <p:cNvSpPr txBox="1"/>
                  <p:nvPr/>
                </p:nvSpPr>
                <p:spPr>
                  <a:xfrm>
                    <a:off x="-1552725" y="3831426"/>
                    <a:ext cx="244522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        </a:t>
                    </a:r>
                    <a:r>
                      <a:rPr kumimoji="1" lang="en-US" altLang="ja-JP" sz="1200" spc="-1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</a:t>
                    </a:r>
                    <a:r>
                      <a: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        10      </a:t>
                    </a:r>
                    <a:r>
                      <a:rPr kumimoji="1" lang="en-US" altLang="ja-JP" sz="1200" spc="-1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</a:t>
                    </a:r>
                    <a:r>
                      <a:rPr kumimoji="1" lang="en-US" altLang="ja-JP" sz="1050" spc="-1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</a:t>
                    </a:r>
                    <a:r>
                      <a: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    </a:t>
                    </a:r>
                    <a:r>
                      <a:rPr kumimoji="1" lang="en-US" altLang="ja-JP" sz="1200" spc="-1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</a:t>
                    </a:r>
                    <a:r>
                      <a:rPr kumimoji="1" lang="en-US" altLang="ja-JP" sz="1200" spc="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  <a:endParaRPr kumimoji="1" lang="ja-JP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1" name="グループ化 10">
                    <a:extLst>
                      <a:ext uri="{FF2B5EF4-FFF2-40B4-BE49-F238E27FC236}">
                        <a16:creationId xmlns:a16="http://schemas.microsoft.com/office/drawing/2014/main" id="{4636D6CC-9970-4320-864E-1C8A2E15140F}"/>
                      </a:ext>
                    </a:extLst>
                  </p:cNvPr>
                  <p:cNvGrpSpPr/>
                  <p:nvPr/>
                </p:nvGrpSpPr>
                <p:grpSpPr>
                  <a:xfrm>
                    <a:off x="-1444880" y="2341854"/>
                    <a:ext cx="75352" cy="1163173"/>
                    <a:chOff x="940752" y="2132477"/>
                    <a:chExt cx="75352" cy="1163173"/>
                  </a:xfrm>
                </p:grpSpPr>
                <p:cxnSp>
                  <p:nvCxnSpPr>
                    <p:cNvPr id="19" name="直線コネクタ 18">
                      <a:extLst>
                        <a:ext uri="{FF2B5EF4-FFF2-40B4-BE49-F238E27FC236}">
                          <a16:creationId xmlns:a16="http://schemas.microsoft.com/office/drawing/2014/main" id="{AB0312FA-FF59-4777-9C93-4BB9F57850C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944104" y="2132477"/>
                      <a:ext cx="720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" name="直線コネクタ 19">
                      <a:extLst>
                        <a:ext uri="{FF2B5EF4-FFF2-40B4-BE49-F238E27FC236}">
                          <a16:creationId xmlns:a16="http://schemas.microsoft.com/office/drawing/2014/main" id="{01966A54-7284-446E-80C5-968BB897239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940752" y="2419351"/>
                      <a:ext cx="720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" name="直線コネクタ 20">
                      <a:extLst>
                        <a:ext uri="{FF2B5EF4-FFF2-40B4-BE49-F238E27FC236}">
                          <a16:creationId xmlns:a16="http://schemas.microsoft.com/office/drawing/2014/main" id="{BC9CFD2F-043F-4E0E-A8B7-25607E58BD5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940752" y="2714626"/>
                      <a:ext cx="720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" name="直線コネクタ 21">
                      <a:extLst>
                        <a:ext uri="{FF2B5EF4-FFF2-40B4-BE49-F238E27FC236}">
                          <a16:creationId xmlns:a16="http://schemas.microsoft.com/office/drawing/2014/main" id="{76BED6CC-B1BF-42EC-9392-3C48DECAD17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940752" y="3005138"/>
                      <a:ext cx="720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" name="直線コネクタ 22">
                      <a:extLst>
                        <a:ext uri="{FF2B5EF4-FFF2-40B4-BE49-F238E27FC236}">
                          <a16:creationId xmlns:a16="http://schemas.microsoft.com/office/drawing/2014/main" id="{0F4262AF-95DA-48B6-8821-15406B7697A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940752" y="3295650"/>
                      <a:ext cx="720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2" name="グループ化 11">
                    <a:extLst>
                      <a:ext uri="{FF2B5EF4-FFF2-40B4-BE49-F238E27FC236}">
                        <a16:creationId xmlns:a16="http://schemas.microsoft.com/office/drawing/2014/main" id="{FEC1FF6D-4EB5-44F1-884B-66B9609AC257}"/>
                      </a:ext>
                    </a:extLst>
                  </p:cNvPr>
                  <p:cNvGrpSpPr/>
                  <p:nvPr/>
                </p:nvGrpSpPr>
                <p:grpSpPr>
                  <a:xfrm>
                    <a:off x="-1444880" y="3731590"/>
                    <a:ext cx="2045368" cy="72000"/>
                    <a:chOff x="940752" y="3609663"/>
                    <a:chExt cx="2045368" cy="72000"/>
                  </a:xfrm>
                </p:grpSpPr>
                <p:cxnSp>
                  <p:nvCxnSpPr>
                    <p:cNvPr id="14" name="直線コネクタ 13">
                      <a:extLst>
                        <a:ext uri="{FF2B5EF4-FFF2-40B4-BE49-F238E27FC236}">
                          <a16:creationId xmlns:a16="http://schemas.microsoft.com/office/drawing/2014/main" id="{0C59D5BB-6FF1-453B-BF81-7F7867F4C8A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40752" y="3681663"/>
                      <a:ext cx="2045368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" name="直線コネクタ 14">
                      <a:extLst>
                        <a:ext uri="{FF2B5EF4-FFF2-40B4-BE49-F238E27FC236}">
                          <a16:creationId xmlns:a16="http://schemas.microsoft.com/office/drawing/2014/main" id="{DA2B5E89-ECCB-440D-A7AD-8AF52460D57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963436" y="3609663"/>
                      <a:ext cx="0" cy="72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" name="直線コネクタ 15">
                      <a:extLst>
                        <a:ext uri="{FF2B5EF4-FFF2-40B4-BE49-F238E27FC236}">
                          <a16:creationId xmlns:a16="http://schemas.microsoft.com/office/drawing/2014/main" id="{86A96E4D-4D16-479A-8887-28F12D51079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2986120" y="3609663"/>
                      <a:ext cx="0" cy="72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" name="直線コネクタ 16">
                      <a:extLst>
                        <a:ext uri="{FF2B5EF4-FFF2-40B4-BE49-F238E27FC236}">
                          <a16:creationId xmlns:a16="http://schemas.microsoft.com/office/drawing/2014/main" id="{43B9C75D-F362-482B-B1A4-9E48B7621A0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2490820" y="3609663"/>
                      <a:ext cx="0" cy="72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" name="直線コネクタ 17">
                      <a:extLst>
                        <a:ext uri="{FF2B5EF4-FFF2-40B4-BE49-F238E27FC236}">
                          <a16:creationId xmlns:a16="http://schemas.microsoft.com/office/drawing/2014/main" id="{B217306E-6EB5-49B3-BAE4-BF8F705FC70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447833" y="3609663"/>
                      <a:ext cx="0" cy="72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" name="テキスト ボックス 12">
                    <a:extLst>
                      <a:ext uri="{FF2B5EF4-FFF2-40B4-BE49-F238E27FC236}">
                        <a16:creationId xmlns:a16="http://schemas.microsoft.com/office/drawing/2014/main" id="{780AA676-44CE-4A4F-A9F8-3A7F339C5705}"/>
                      </a:ext>
                    </a:extLst>
                  </p:cNvPr>
                  <p:cNvSpPr txBox="1"/>
                  <p:nvPr/>
                </p:nvSpPr>
                <p:spPr>
                  <a:xfrm>
                    <a:off x="-1446239" y="4087241"/>
                    <a:ext cx="255061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/4central visual field (degree)</a:t>
                    </a:r>
                    <a:endParaRPr kumimoji="1" lang="ja-JP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aphicFrame>
              <p:nvGraphicFramePr>
                <p:cNvPr id="8" name="グラフ 7">
                  <a:extLst>
                    <a:ext uri="{FF2B5EF4-FFF2-40B4-BE49-F238E27FC236}">
                      <a16:creationId xmlns:a16="http://schemas.microsoft.com/office/drawing/2014/main" id="{31E2D109-50A8-4ADF-B6D4-10C5E904ED11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750668" y="2422818"/>
                <a:ext cx="2628000" cy="176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cxnSp>
              <p:nvCxnSpPr>
                <p:cNvPr id="9" name="直線コネクタ 8">
                  <a:extLst>
                    <a:ext uri="{FF2B5EF4-FFF2-40B4-BE49-F238E27FC236}">
                      <a16:creationId xmlns:a16="http://schemas.microsoft.com/office/drawing/2014/main" id="{8ACBF769-ACED-454E-8E90-F5450DC4CC6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224364" y="2579622"/>
                  <a:ext cx="1129" cy="145732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71745945-6E98-426C-9B9B-6F3B85D819F5}"/>
                  </a:ext>
                </a:extLst>
              </p:cNvPr>
              <p:cNvSpPr txBox="1"/>
              <p:nvPr/>
            </p:nvSpPr>
            <p:spPr>
              <a:xfrm rot="16200000">
                <a:off x="-355582" y="2460591"/>
                <a:ext cx="2054697" cy="4127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egressive Saccade  %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05D24F3D-E0FB-4B48-9650-B83315776E5B}"/>
                </a:ext>
              </a:extLst>
            </p:cNvPr>
            <p:cNvSpPr txBox="1"/>
            <p:nvPr/>
          </p:nvSpPr>
          <p:spPr>
            <a:xfrm>
              <a:off x="391810" y="1236239"/>
              <a:ext cx="36188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51EF8105-AC10-4F50-982E-9B901C5F0CB7}"/>
              </a:ext>
            </a:extLst>
          </p:cNvPr>
          <p:cNvSpPr txBox="1"/>
          <p:nvPr/>
        </p:nvSpPr>
        <p:spPr>
          <a:xfrm>
            <a:off x="188615" y="8203969"/>
            <a:ext cx="648076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ea typeface="游明朝" panose="02020400000000000000" pitchFamily="18" charset="-128"/>
                <a:cs typeface="Arial" panose="020B0604020202020204" pitchFamily="34" charset="0"/>
              </a:rPr>
              <a:t>S</a:t>
            </a:r>
            <a:r>
              <a:rPr lang="en-US" altLang="ja-JP" sz="1600" dirty="0"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ea typeface="游明朝" panose="02020400000000000000" pitchFamily="18" charset="-128"/>
                <a:cs typeface="Arial" panose="020B0604020202020204" pitchFamily="34" charset="0"/>
              </a:rPr>
              <a:t>Fig. Typical example of correlation analyses between gaze analyses and visual field.</a:t>
            </a:r>
            <a:endParaRPr lang="en-US" altLang="ja-JP" sz="1600" dirty="0">
              <a:effectLst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36F0CBAB-D94D-4301-AB98-8A330E92CBDF}"/>
              </a:ext>
            </a:extLst>
          </p:cNvPr>
          <p:cNvGrpSpPr/>
          <p:nvPr/>
        </p:nvGrpSpPr>
        <p:grpSpPr>
          <a:xfrm>
            <a:off x="377230" y="5829130"/>
            <a:ext cx="3124702" cy="2198273"/>
            <a:chOff x="453886" y="6496323"/>
            <a:chExt cx="3124702" cy="2198273"/>
          </a:xfrm>
        </p:grpSpPr>
        <p:grpSp>
          <p:nvGrpSpPr>
            <p:cNvPr id="56" name="グループ化 55">
              <a:extLst>
                <a:ext uri="{FF2B5EF4-FFF2-40B4-BE49-F238E27FC236}">
                  <a16:creationId xmlns:a16="http://schemas.microsoft.com/office/drawing/2014/main" id="{E5CBE99A-E8C2-4FEF-A327-FC7C7A2607FE}"/>
                </a:ext>
              </a:extLst>
            </p:cNvPr>
            <p:cNvGrpSpPr/>
            <p:nvPr/>
          </p:nvGrpSpPr>
          <p:grpSpPr>
            <a:xfrm>
              <a:off x="604539" y="6576273"/>
              <a:ext cx="2872764" cy="1938992"/>
              <a:chOff x="316095" y="6423839"/>
              <a:chExt cx="2872764" cy="1938992"/>
            </a:xfrm>
          </p:grpSpPr>
          <p:graphicFrame>
            <p:nvGraphicFramePr>
              <p:cNvPr id="81" name="グラフ 80">
                <a:extLst>
                  <a:ext uri="{FF2B5EF4-FFF2-40B4-BE49-F238E27FC236}">
                    <a16:creationId xmlns:a16="http://schemas.microsoft.com/office/drawing/2014/main" id="{238EC760-2D0E-4322-BE31-F297775B0CF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59192381"/>
                  </p:ext>
                </p:extLst>
              </p:nvPr>
            </p:nvGraphicFramePr>
            <p:xfrm>
              <a:off x="714684" y="6428896"/>
              <a:ext cx="2304000" cy="1728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pSp>
            <p:nvGrpSpPr>
              <p:cNvPr id="37" name="グループ化 36">
                <a:extLst>
                  <a:ext uri="{FF2B5EF4-FFF2-40B4-BE49-F238E27FC236}">
                    <a16:creationId xmlns:a16="http://schemas.microsoft.com/office/drawing/2014/main" id="{E28DA42F-F62F-4DC0-B2E5-BE47F70138F8}"/>
                  </a:ext>
                </a:extLst>
              </p:cNvPr>
              <p:cNvGrpSpPr/>
              <p:nvPr/>
            </p:nvGrpSpPr>
            <p:grpSpPr>
              <a:xfrm>
                <a:off x="743631" y="7940177"/>
                <a:ext cx="2445228" cy="373056"/>
                <a:chOff x="743631" y="7940177"/>
                <a:chExt cx="2445228" cy="373056"/>
              </a:xfrm>
            </p:grpSpPr>
            <p:sp>
              <p:nvSpPr>
                <p:cNvPr id="91" name="テキスト ボックス 90">
                  <a:extLst>
                    <a:ext uri="{FF2B5EF4-FFF2-40B4-BE49-F238E27FC236}">
                      <a16:creationId xmlns:a16="http://schemas.microsoft.com/office/drawing/2014/main" id="{7720CAEA-F2B2-44B9-84EC-CB06BE61EAD2}"/>
                    </a:ext>
                  </a:extLst>
                </p:cNvPr>
                <p:cNvSpPr txBox="1"/>
                <p:nvPr/>
              </p:nvSpPr>
              <p:spPr>
                <a:xfrm>
                  <a:off x="743631" y="8036234"/>
                  <a:ext cx="244522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</a:t>
                  </a:r>
                  <a:r>
                    <a:rPr kumimoji="1" lang="en-US" altLang="ja-JP" sz="1200" spc="-1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         10      </a:t>
                  </a:r>
                  <a:r>
                    <a:rPr kumimoji="1" lang="en-US" altLang="ja-JP" sz="1200" spc="-1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kumimoji="1" lang="en-US" altLang="ja-JP" sz="1050" spc="-1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    </a:t>
                  </a:r>
                  <a:r>
                    <a:rPr kumimoji="1" lang="en-US" altLang="ja-JP" sz="1200" spc="-1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kumimoji="1" lang="en-US" altLang="ja-JP" sz="1200" spc="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1" name="直線コネクタ 100">
                  <a:extLst>
                    <a:ext uri="{FF2B5EF4-FFF2-40B4-BE49-F238E27FC236}">
                      <a16:creationId xmlns:a16="http://schemas.microsoft.com/office/drawing/2014/main" id="{4D4E98FB-616E-4732-B879-78F38BB9B8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4000" y="8012177"/>
                  <a:ext cx="204536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線コネクタ 103">
                  <a:extLst>
                    <a:ext uri="{FF2B5EF4-FFF2-40B4-BE49-F238E27FC236}">
                      <a16:creationId xmlns:a16="http://schemas.microsoft.com/office/drawing/2014/main" id="{A6BA3EDC-791E-4D84-AC46-A4A4066DF5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346569" y="7940177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線コネクタ 104">
                  <a:extLst>
                    <a:ext uri="{FF2B5EF4-FFF2-40B4-BE49-F238E27FC236}">
                      <a16:creationId xmlns:a16="http://schemas.microsoft.com/office/drawing/2014/main" id="{6DA08713-C006-40C6-8090-8826FEAEB5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867846" y="7940177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直線コネクタ 105">
                  <a:extLst>
                    <a:ext uri="{FF2B5EF4-FFF2-40B4-BE49-F238E27FC236}">
                      <a16:creationId xmlns:a16="http://schemas.microsoft.com/office/drawing/2014/main" id="{F8C8AFA2-4B08-46DA-9F41-7E3551CB91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402503" y="7940177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コネクタ 106">
                  <a:extLst>
                    <a:ext uri="{FF2B5EF4-FFF2-40B4-BE49-F238E27FC236}">
                      <a16:creationId xmlns:a16="http://schemas.microsoft.com/office/drawing/2014/main" id="{AA7F9C22-597E-4034-8EBC-0B5DBC87F9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883136" y="7940177"/>
                  <a:ext cx="0" cy="720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3" name="グループ化 52">
                <a:extLst>
                  <a:ext uri="{FF2B5EF4-FFF2-40B4-BE49-F238E27FC236}">
                    <a16:creationId xmlns:a16="http://schemas.microsoft.com/office/drawing/2014/main" id="{1A33D6DF-B4E2-4B0F-B2F2-4BCA388C6788}"/>
                  </a:ext>
                </a:extLst>
              </p:cNvPr>
              <p:cNvGrpSpPr/>
              <p:nvPr/>
            </p:nvGrpSpPr>
            <p:grpSpPr>
              <a:xfrm>
                <a:off x="316095" y="6423839"/>
                <a:ext cx="579117" cy="1938992"/>
                <a:chOff x="316095" y="6423839"/>
                <a:chExt cx="579117" cy="1938992"/>
              </a:xfrm>
            </p:grpSpPr>
            <p:grpSp>
              <p:nvGrpSpPr>
                <p:cNvPr id="93" name="グループ化 92">
                  <a:extLst>
                    <a:ext uri="{FF2B5EF4-FFF2-40B4-BE49-F238E27FC236}">
                      <a16:creationId xmlns:a16="http://schemas.microsoft.com/office/drawing/2014/main" id="{28C27D64-FA16-4387-B031-C6F9EF3BCBF7}"/>
                    </a:ext>
                  </a:extLst>
                </p:cNvPr>
                <p:cNvGrpSpPr/>
                <p:nvPr/>
              </p:nvGrpSpPr>
              <p:grpSpPr>
                <a:xfrm>
                  <a:off x="837371" y="6572896"/>
                  <a:ext cx="57841" cy="1440000"/>
                  <a:chOff x="904475" y="1307715"/>
                  <a:chExt cx="66326" cy="1453162"/>
                </a:xfrm>
              </p:grpSpPr>
              <p:cxnSp>
                <p:nvCxnSpPr>
                  <p:cNvPr id="94" name="直線コネクタ 93">
                    <a:extLst>
                      <a:ext uri="{FF2B5EF4-FFF2-40B4-BE49-F238E27FC236}">
                        <a16:creationId xmlns:a16="http://schemas.microsoft.com/office/drawing/2014/main" id="{77126B09-5DE5-4CFF-98BE-9BB62F79F25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4475" y="1307715"/>
                    <a:ext cx="6127" cy="145243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" name="直線コネクタ 94">
                    <a:extLst>
                      <a:ext uri="{FF2B5EF4-FFF2-40B4-BE49-F238E27FC236}">
                        <a16:creationId xmlns:a16="http://schemas.microsoft.com/office/drawing/2014/main" id="{F33FE2F3-2F04-44E7-ADC8-3B343E394D5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8050" y="2035981"/>
                    <a:ext cx="44968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6" name="直線コネクタ 95">
                    <a:extLst>
                      <a:ext uri="{FF2B5EF4-FFF2-40B4-BE49-F238E27FC236}">
                        <a16:creationId xmlns:a16="http://schemas.microsoft.com/office/drawing/2014/main" id="{6AC8D52E-BB3C-4712-A688-73329F9C23E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17651" y="1676830"/>
                    <a:ext cx="44968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直線コネクタ 96">
                    <a:extLst>
                      <a:ext uri="{FF2B5EF4-FFF2-40B4-BE49-F238E27FC236}">
                        <a16:creationId xmlns:a16="http://schemas.microsoft.com/office/drawing/2014/main" id="{2F21294B-67C3-44F5-BC4C-2A6B301EF49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4475" y="1307715"/>
                    <a:ext cx="44968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直線コネクタ 97">
                    <a:extLst>
                      <a:ext uri="{FF2B5EF4-FFF2-40B4-BE49-F238E27FC236}">
                        <a16:creationId xmlns:a16="http://schemas.microsoft.com/office/drawing/2014/main" id="{1D7816F1-0AE8-4187-86EB-2305FA15E05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4475" y="2395640"/>
                    <a:ext cx="44968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直線コネクタ 98">
                    <a:extLst>
                      <a:ext uri="{FF2B5EF4-FFF2-40B4-BE49-F238E27FC236}">
                        <a16:creationId xmlns:a16="http://schemas.microsoft.com/office/drawing/2014/main" id="{299B3184-35D5-4C53-855F-96C3E520F87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9470" y="2760877"/>
                    <a:ext cx="61331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D9DE2C4F-0D88-490F-8B41-51D7831051E9}"/>
                    </a:ext>
                  </a:extLst>
                </p:cNvPr>
                <p:cNvSpPr txBox="1"/>
                <p:nvPr/>
              </p:nvSpPr>
              <p:spPr>
                <a:xfrm>
                  <a:off x="316095" y="6423839"/>
                  <a:ext cx="515595" cy="19389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  <a:p>
                  <a:pPr algn="r"/>
                  <a:endPara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  <a:p>
                  <a:pPr algn="r"/>
                  <a:endPara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  <a:p>
                  <a:pPr algn="r"/>
                  <a:endPara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  <a:p>
                  <a:pPr algn="r"/>
                  <a:endPara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  <a:p>
                  <a:pPr algn="r"/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451C3476-F56C-461D-A7CA-897169F49C88}"/>
                </a:ext>
              </a:extLst>
            </p:cNvPr>
            <p:cNvSpPr txBox="1"/>
            <p:nvPr/>
          </p:nvSpPr>
          <p:spPr>
            <a:xfrm rot="16200000">
              <a:off x="-284821" y="7235030"/>
              <a:ext cx="1939079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ja-JP" altLang="ja-JP" sz="12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Task performance time</a:t>
              </a:r>
              <a:endParaRPr lang="en-US" altLang="ja-JP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/>
              <a:r>
                <a:rPr lang="ja-JP" altLang="ja-JP" sz="12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（</a:t>
              </a:r>
              <a:r>
                <a:rPr lang="ja-JP" altLang="ja-JP" sz="12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ec</a:t>
              </a:r>
              <a:r>
                <a:rPr lang="ja-JP" altLang="ja-JP" sz="12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）</a:t>
              </a:r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F2F08BEA-FA42-43A0-B873-AFCCF108BDF6}"/>
                </a:ext>
              </a:extLst>
            </p:cNvPr>
            <p:cNvSpPr txBox="1"/>
            <p:nvPr/>
          </p:nvSpPr>
          <p:spPr>
            <a:xfrm>
              <a:off x="1334607" y="8417597"/>
              <a:ext cx="22439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I/4central visual field  (degree)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37052167"/>
      </p:ext>
    </p:extLst>
  </p:cSld>
  <p:clrMapOvr>
    <a:masterClrMapping/>
  </p:clrMapOvr>
</p:sld>
</file>

<file path=ppt/theme/theme1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2</TotalTime>
  <Words>133</Words>
  <Application>Microsoft Office PowerPoint</Application>
  <PresentationFormat>画面に合わせる (4:3)</PresentationFormat>
  <Paragraphs>3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デザインの設定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da</dc:creator>
  <cp:lastModifiedBy>yoshida</cp:lastModifiedBy>
  <cp:revision>114</cp:revision>
  <dcterms:created xsi:type="dcterms:W3CDTF">2022-01-23T19:16:53Z</dcterms:created>
  <dcterms:modified xsi:type="dcterms:W3CDTF">2022-10-04T13:31:38Z</dcterms:modified>
</cp:coreProperties>
</file>